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mv" ContentType="video/x-ms-wmv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46" d="100"/>
          <a:sy n="46" d="100"/>
        </p:scale>
        <p:origin x="243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5414D-6F86-4039-BF27-D5B1BF713A57}" type="datetimeFigureOut">
              <a:rPr lang="en-GB" smtClean="0"/>
              <a:t>12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A057F-5377-4FFD-8AF2-83B78F8E1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7412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5414D-6F86-4039-BF27-D5B1BF713A57}" type="datetimeFigureOut">
              <a:rPr lang="en-GB" smtClean="0"/>
              <a:t>12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A057F-5377-4FFD-8AF2-83B78F8E1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42203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5414D-6F86-4039-BF27-D5B1BF713A57}" type="datetimeFigureOut">
              <a:rPr lang="en-GB" smtClean="0"/>
              <a:t>12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A057F-5377-4FFD-8AF2-83B78F8E1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1129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5414D-6F86-4039-BF27-D5B1BF713A57}" type="datetimeFigureOut">
              <a:rPr lang="en-GB" smtClean="0"/>
              <a:t>12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A057F-5377-4FFD-8AF2-83B78F8E1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503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5414D-6F86-4039-BF27-D5B1BF713A57}" type="datetimeFigureOut">
              <a:rPr lang="en-GB" smtClean="0"/>
              <a:t>12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A057F-5377-4FFD-8AF2-83B78F8E1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789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5414D-6F86-4039-BF27-D5B1BF713A57}" type="datetimeFigureOut">
              <a:rPr lang="en-GB" smtClean="0"/>
              <a:t>12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A057F-5377-4FFD-8AF2-83B78F8E1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92816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5414D-6F86-4039-BF27-D5B1BF713A57}" type="datetimeFigureOut">
              <a:rPr lang="en-GB" smtClean="0"/>
              <a:t>12/10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A057F-5377-4FFD-8AF2-83B78F8E1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98835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5414D-6F86-4039-BF27-D5B1BF713A57}" type="datetimeFigureOut">
              <a:rPr lang="en-GB" smtClean="0"/>
              <a:t>12/10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A057F-5377-4FFD-8AF2-83B78F8E1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8084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5414D-6F86-4039-BF27-D5B1BF713A57}" type="datetimeFigureOut">
              <a:rPr lang="en-GB" smtClean="0"/>
              <a:t>12/10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A057F-5377-4FFD-8AF2-83B78F8E1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1230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5414D-6F86-4039-BF27-D5B1BF713A57}" type="datetimeFigureOut">
              <a:rPr lang="en-GB" smtClean="0"/>
              <a:t>12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A057F-5377-4FFD-8AF2-83B78F8E1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67166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5414D-6F86-4039-BF27-D5B1BF713A57}" type="datetimeFigureOut">
              <a:rPr lang="en-GB" smtClean="0"/>
              <a:t>12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A057F-5377-4FFD-8AF2-83B78F8E1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0572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F75414D-6F86-4039-BF27-D5B1BF713A57}" type="datetimeFigureOut">
              <a:rPr lang="en-GB" smtClean="0"/>
              <a:t>12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F1A057F-5377-4FFD-8AF2-83B78F8E1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5164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wmv"/><Relationship Id="rId1" Type="http://schemas.microsoft.com/office/2007/relationships/media" Target="../media/media1.wmv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edia1">
            <a:hlinkClick r:id="" action="ppaction://media"/>
            <a:extLst>
              <a:ext uri="{FF2B5EF4-FFF2-40B4-BE49-F238E27FC236}">
                <a16:creationId xmlns:a16="http://schemas.microsoft.com/office/drawing/2014/main" id="{3B943EB5-3A44-308D-6CD1-75B2D03A1C7D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78998" y="838804"/>
            <a:ext cx="5700004" cy="557988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7E55609-F68E-9DCA-1DC4-84C027842E0D}"/>
              </a:ext>
            </a:extLst>
          </p:cNvPr>
          <p:cNvSpPr txBox="1"/>
          <p:nvPr/>
        </p:nvSpPr>
        <p:spPr>
          <a:xfrm>
            <a:off x="477984" y="270165"/>
            <a:ext cx="3657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ppendix A. Supplementary figur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16FC795-228B-2765-E5E7-2365E6D8637C}"/>
              </a:ext>
            </a:extLst>
          </p:cNvPr>
          <p:cNvSpPr txBox="1"/>
          <p:nvPr/>
        </p:nvSpPr>
        <p:spPr>
          <a:xfrm>
            <a:off x="578997" y="6721902"/>
            <a:ext cx="570000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1. Representative movie showing renal clearance of intravenously injected ABZWCY-HPβCD over a period of 40 minutes. 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5360454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155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25</Words>
  <Application>Microsoft Office PowerPoint</Application>
  <PresentationFormat>A4 Paper (210x297 mm)</PresentationFormat>
  <Paragraphs>2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The University of Liverpo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urray, Patricia</dc:creator>
  <cp:lastModifiedBy>Murray, Patricia</cp:lastModifiedBy>
  <cp:revision>2</cp:revision>
  <dcterms:created xsi:type="dcterms:W3CDTF">2024-10-12T06:34:25Z</dcterms:created>
  <dcterms:modified xsi:type="dcterms:W3CDTF">2024-10-12T06:49:59Z</dcterms:modified>
</cp:coreProperties>
</file>